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1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0979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6098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254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275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120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492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6658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9614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9358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8481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9920B-918B-46ED-B2B0-BC9CD764005F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51CBC-8DDA-482D-A5A8-353DD6F09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5370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5" Type="http://schemas.openxmlformats.org/officeDocument/2006/relationships/image" Target="../media/image3.tiff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microsoft.com/office/2007/relationships/hdphoto" Target="../media/hdphoto1.wdp"/><Relationship Id="rId7" Type="http://schemas.openxmlformats.org/officeDocument/2006/relationships/image" Target="../media/image10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4.png"/><Relationship Id="rId7" Type="http://schemas.openxmlformats.org/officeDocument/2006/relationships/image" Target="../media/image1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7.png"/><Relationship Id="rId7" Type="http://schemas.openxmlformats.org/officeDocument/2006/relationships/image" Target="../media/image18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microsoft.com/office/2007/relationships/hdphoto" Target="../media/hdphoto3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 rot="16200000">
            <a:off x="3429430" y="1929768"/>
            <a:ext cx="5524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 rot="16200000">
            <a:off x="3566830" y="1960692"/>
            <a:ext cx="4906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3535199" y="1838611"/>
            <a:ext cx="7686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3826700" y="197652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3957801" y="197652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6200000">
            <a:off x="4061776" y="197652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3666010" y="1961621"/>
            <a:ext cx="329176" cy="272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3992997" y="1961272"/>
            <a:ext cx="385867" cy="27508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el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0361582"/>
              </p:ext>
            </p:extLst>
          </p:nvPr>
        </p:nvGraphicFramePr>
        <p:xfrm>
          <a:off x="3398355" y="1961621"/>
          <a:ext cx="262028" cy="2759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1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5901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13" name="Gruppieren 12"/>
          <p:cNvGrpSpPr/>
          <p:nvPr/>
        </p:nvGrpSpPr>
        <p:grpSpPr>
          <a:xfrm>
            <a:off x="3326924" y="1557778"/>
            <a:ext cx="1128036" cy="435724"/>
            <a:chOff x="276551" y="3642339"/>
            <a:chExt cx="1128036" cy="435724"/>
          </a:xfrm>
        </p:grpSpPr>
        <p:sp>
          <p:nvSpPr>
            <p:cNvPr id="14" name="Textfeld 13"/>
            <p:cNvSpPr txBox="1"/>
            <p:nvPr/>
          </p:nvSpPr>
          <p:spPr>
            <a:xfrm>
              <a:off x="625451" y="3642339"/>
              <a:ext cx="68833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DD-IP  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Gerade Verbindung 241"/>
            <p:cNvCxnSpPr/>
            <p:nvPr/>
          </p:nvCxnSpPr>
          <p:spPr>
            <a:xfrm flipH="1">
              <a:off x="617848" y="3803159"/>
              <a:ext cx="7178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/>
            <p:cNvSpPr txBox="1"/>
            <p:nvPr/>
          </p:nvSpPr>
          <p:spPr>
            <a:xfrm>
              <a:off x="276551" y="3867440"/>
              <a:ext cx="4578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856327" y="3831842"/>
              <a:ext cx="5482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ZC </a:t>
              </a:r>
            </a:p>
            <a:p>
              <a:pPr algn="ctr"/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2 h </a:t>
              </a:r>
              <a:r>
                <a:rPr lang="de-DE" sz="5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m</a:t>
              </a:r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5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Gerade Verbindung 244"/>
            <p:cNvCxnSpPr/>
            <p:nvPr/>
          </p:nvCxnSpPr>
          <p:spPr>
            <a:xfrm flipH="1">
              <a:off x="357177" y="4005910"/>
              <a:ext cx="229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hteck 18"/>
            <p:cNvSpPr/>
            <p:nvPr/>
          </p:nvSpPr>
          <p:spPr>
            <a:xfrm>
              <a:off x="610010" y="3855014"/>
              <a:ext cx="334803" cy="19387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hteck 19"/>
            <p:cNvSpPr/>
            <p:nvPr/>
          </p:nvSpPr>
          <p:spPr>
            <a:xfrm>
              <a:off x="942062" y="3855015"/>
              <a:ext cx="386430" cy="19235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55238" y="3898013"/>
              <a:ext cx="64807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de-DE" sz="5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5" t="26496" r="29955" b="63434"/>
          <a:stretch/>
        </p:blipFill>
        <p:spPr>
          <a:xfrm>
            <a:off x="3401051" y="3117083"/>
            <a:ext cx="972000" cy="1712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64" t="28487" r="27997" b="65925"/>
          <a:stretch/>
        </p:blipFill>
        <p:spPr>
          <a:xfrm>
            <a:off x="3401051" y="2240235"/>
            <a:ext cx="972000" cy="950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64" t="31095" r="32895" b="58661"/>
          <a:stretch/>
        </p:blipFill>
        <p:spPr>
          <a:xfrm>
            <a:off x="3401051" y="2431946"/>
            <a:ext cx="972000" cy="1741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78" t="31073" r="32782" b="41796"/>
          <a:stretch/>
        </p:blipFill>
        <p:spPr>
          <a:xfrm>
            <a:off x="3401051" y="2630495"/>
            <a:ext cx="972000" cy="4613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78" t="36583" r="59462" b="59356"/>
          <a:stretch/>
        </p:blipFill>
        <p:spPr>
          <a:xfrm>
            <a:off x="3401051" y="3655085"/>
            <a:ext cx="234000" cy="711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67" t="49884" r="28594" b="45791"/>
          <a:stretch/>
        </p:blipFill>
        <p:spPr>
          <a:xfrm>
            <a:off x="3400478" y="2345670"/>
            <a:ext cx="972000" cy="735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49" t="35615" r="30411" b="44773"/>
          <a:stretch/>
        </p:blipFill>
        <p:spPr>
          <a:xfrm>
            <a:off x="3401051" y="3307779"/>
            <a:ext cx="972000" cy="3334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4457718" y="3246852"/>
            <a:ext cx="5231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457718" y="3304337"/>
            <a:ext cx="4260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457718" y="3393534"/>
            <a:ext cx="8576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baseline="-25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4457718" y="3068928"/>
            <a:ext cx="10309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4457718" y="3143094"/>
            <a:ext cx="3817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457718" y="2376406"/>
            <a:ext cx="12125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4457718" y="2573380"/>
            <a:ext cx="12416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457718" y="2657536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457718" y="2947133"/>
            <a:ext cx="426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457718" y="2192080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4464428" y="2465306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457718" y="3620045"/>
            <a:ext cx="426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Gerade Verbindung mit Pfeil 40"/>
          <p:cNvCxnSpPr/>
          <p:nvPr/>
        </p:nvCxnSpPr>
        <p:spPr>
          <a:xfrm flipH="1">
            <a:off x="4383439" y="334588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4383439" y="34080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4383439" y="315518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flipH="1">
            <a:off x="4383439" y="35793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4383439" y="317536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4382866" y="23869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4383439" y="228002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>
            <a:off x="4383439" y="305068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4383439" y="372320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4383439" y="254638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4383439" y="256656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4382876" y="265736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 flipH="1">
            <a:off x="4382876" y="267754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H="1">
            <a:off x="4383439" y="273832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H="1">
            <a:off x="4383439" y="275850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 flipH="1">
            <a:off x="4383439" y="24658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>
          <a:xfrm flipH="1">
            <a:off x="4383439" y="24860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 flipH="1">
            <a:off x="4383439" y="324204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/>
        </p:nvSpPr>
        <p:spPr>
          <a:xfrm>
            <a:off x="4457145" y="2304433"/>
            <a:ext cx="7225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baseline="-25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038833" y="2196613"/>
            <a:ext cx="4200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2888941" y="2097786"/>
            <a:ext cx="5699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124382" y="3280760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2947694" y="2441270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124382" y="3614218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017615" y="3091296"/>
            <a:ext cx="441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123809" y="2309823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3124382" y="3445927"/>
            <a:ext cx="3345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3631165" y="1417697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4303960" y="2822117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4291265" y="3392906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2947694" y="2619490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2950516" y="2688749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2948649" y="2961609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3120538" y="3354664"/>
            <a:ext cx="3345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2573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64" t="28487" r="27997" b="65925"/>
          <a:stretch/>
        </p:blipFill>
        <p:spPr>
          <a:xfrm>
            <a:off x="765428" y="150178"/>
            <a:ext cx="972000" cy="950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67" t="49884" r="28594" b="45791"/>
          <a:stretch/>
        </p:blipFill>
        <p:spPr>
          <a:xfrm>
            <a:off x="6320410" y="171644"/>
            <a:ext cx="972000" cy="735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feld 35"/>
          <p:cNvSpPr txBox="1"/>
          <p:nvPr/>
        </p:nvSpPr>
        <p:spPr>
          <a:xfrm>
            <a:off x="1822095" y="102023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Gerade Verbindung mit Pfeil 43"/>
          <p:cNvCxnSpPr/>
          <p:nvPr/>
        </p:nvCxnSpPr>
        <p:spPr>
          <a:xfrm flipH="1">
            <a:off x="7302798" y="21292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1747816" y="18997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feld 56"/>
          <p:cNvSpPr txBox="1"/>
          <p:nvPr/>
        </p:nvSpPr>
        <p:spPr>
          <a:xfrm>
            <a:off x="7377077" y="130407"/>
            <a:ext cx="7225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baseline="-25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403210" y="106556"/>
            <a:ext cx="4200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6043741" y="135797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555" b="28807"/>
          <a:stretch/>
        </p:blipFill>
        <p:spPr>
          <a:xfrm>
            <a:off x="84908" y="3625343"/>
            <a:ext cx="4487091" cy="2962003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9" t="10246" r="19555" b="27699"/>
          <a:stretch/>
        </p:blipFill>
        <p:spPr>
          <a:xfrm>
            <a:off x="229267" y="374637"/>
            <a:ext cx="3204242" cy="2581835"/>
          </a:xfrm>
          <a:prstGeom prst="rect">
            <a:avLst/>
          </a:prstGeom>
        </p:spPr>
      </p:pic>
      <p:pic>
        <p:nvPicPr>
          <p:cNvPr id="75" name="Grafik 7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8" t="3597" r="19011" b="23271"/>
          <a:stretch/>
        </p:blipFill>
        <p:spPr>
          <a:xfrm>
            <a:off x="4718189" y="3625343"/>
            <a:ext cx="4294990" cy="3042685"/>
          </a:xfrm>
          <a:prstGeom prst="rect">
            <a:avLst/>
          </a:prstGeom>
        </p:spPr>
      </p:pic>
      <p:pic>
        <p:nvPicPr>
          <p:cNvPr id="76" name="Grafik 7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88" t="13200" r="21346" b="22158"/>
          <a:stretch/>
        </p:blipFill>
        <p:spPr>
          <a:xfrm>
            <a:off x="5332720" y="291222"/>
            <a:ext cx="3065929" cy="2689412"/>
          </a:xfrm>
          <a:prstGeom prst="rect">
            <a:avLst/>
          </a:prstGeom>
        </p:spPr>
      </p:pic>
      <p:sp>
        <p:nvSpPr>
          <p:cNvPr id="77" name="Rechteck 76"/>
          <p:cNvSpPr/>
          <p:nvPr/>
        </p:nvSpPr>
        <p:spPr>
          <a:xfrm>
            <a:off x="733956" y="377826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733956" y="45182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733956" y="46056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33956" y="46969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733956" y="47976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33956" y="49981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733956" y="52105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733956" y="55287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733956" y="57586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733956" y="6037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733956" y="43965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1424441" y="432430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9" name="Rechteck 88"/>
          <p:cNvSpPr/>
          <p:nvPr/>
        </p:nvSpPr>
        <p:spPr>
          <a:xfrm>
            <a:off x="500568" y="1137310"/>
            <a:ext cx="2519257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0" name="Rechteck 89"/>
          <p:cNvSpPr/>
          <p:nvPr/>
        </p:nvSpPr>
        <p:spPr>
          <a:xfrm>
            <a:off x="733956" y="62602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1" name="Rechteck 90"/>
          <p:cNvSpPr/>
          <p:nvPr/>
        </p:nvSpPr>
        <p:spPr>
          <a:xfrm>
            <a:off x="5107813" y="386490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5107813" y="46048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Rechteck 92"/>
          <p:cNvSpPr/>
          <p:nvPr/>
        </p:nvSpPr>
        <p:spPr>
          <a:xfrm>
            <a:off x="5107813" y="46922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4" name="Rechteck 93"/>
          <p:cNvSpPr/>
          <p:nvPr/>
        </p:nvSpPr>
        <p:spPr>
          <a:xfrm>
            <a:off x="5107813" y="47836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5" name="Rechteck 94"/>
          <p:cNvSpPr/>
          <p:nvPr/>
        </p:nvSpPr>
        <p:spPr>
          <a:xfrm>
            <a:off x="5107813" y="48842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6" name="Rechteck 95"/>
          <p:cNvSpPr/>
          <p:nvPr/>
        </p:nvSpPr>
        <p:spPr>
          <a:xfrm>
            <a:off x="5107813" y="50848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5107813" y="52972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5107813" y="56153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5107813" y="58452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5107813" y="61243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107813" y="44832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5798298" y="441094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3" name="Rechteck 102"/>
          <p:cNvSpPr/>
          <p:nvPr/>
        </p:nvSpPr>
        <p:spPr>
          <a:xfrm>
            <a:off x="5569549" y="1820091"/>
            <a:ext cx="2530099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4" name="Rechteck 103"/>
          <p:cNvSpPr/>
          <p:nvPr/>
        </p:nvSpPr>
        <p:spPr>
          <a:xfrm>
            <a:off x="5107813" y="63468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00476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64" t="31095" r="32895" b="58661"/>
          <a:stretch/>
        </p:blipFill>
        <p:spPr>
          <a:xfrm>
            <a:off x="748363" y="257365"/>
            <a:ext cx="972000" cy="1741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78" t="31073" r="32782" b="41796"/>
          <a:stretch/>
        </p:blipFill>
        <p:spPr>
          <a:xfrm>
            <a:off x="6336351" y="141142"/>
            <a:ext cx="972000" cy="4613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feld 11"/>
          <p:cNvSpPr txBox="1"/>
          <p:nvPr/>
        </p:nvSpPr>
        <p:spPr>
          <a:xfrm>
            <a:off x="1805030" y="201825"/>
            <a:ext cx="12125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393018" y="84027"/>
            <a:ext cx="12416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7393018" y="168183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393018" y="457780"/>
            <a:ext cx="426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811740" y="290725"/>
            <a:ext cx="595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 flipH="1">
            <a:off x="7318739" y="5613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1730751" y="37180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1730751" y="3919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7318176" y="16801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7318176" y="1881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flipH="1">
            <a:off x="7318739" y="2489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H="1">
            <a:off x="7318739" y="2691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/>
        </p:nvCxnSpPr>
        <p:spPr>
          <a:xfrm flipH="1">
            <a:off x="1730751" y="29127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/>
          <p:cNvCxnSpPr/>
          <p:nvPr/>
        </p:nvCxnSpPr>
        <p:spPr>
          <a:xfrm flipH="1">
            <a:off x="1730751" y="3114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/>
          <p:cNvSpPr txBox="1"/>
          <p:nvPr/>
        </p:nvSpPr>
        <p:spPr>
          <a:xfrm>
            <a:off x="295006" y="266689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7239260" y="332764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5882994" y="130137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885816" y="199396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5883949" y="472256"/>
            <a:ext cx="5112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101" b="27883"/>
          <a:stretch/>
        </p:blipFill>
        <p:spPr>
          <a:xfrm>
            <a:off x="4705592" y="3659117"/>
            <a:ext cx="4233518" cy="3000423"/>
          </a:xfrm>
          <a:prstGeom prst="rect">
            <a:avLst/>
          </a:prstGeom>
        </p:spPr>
      </p:pic>
      <p:pic>
        <p:nvPicPr>
          <p:cNvPr id="46" name="Grafik 4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1" t="13386" r="23413" b="29360"/>
          <a:stretch/>
        </p:blipFill>
        <p:spPr>
          <a:xfrm>
            <a:off x="676386" y="707390"/>
            <a:ext cx="3204242" cy="2382051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02" t="7660" r="24376" b="27883"/>
          <a:stretch/>
        </p:blipFill>
        <p:spPr>
          <a:xfrm>
            <a:off x="4971569" y="707390"/>
            <a:ext cx="3219610" cy="2681728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74" b="28253"/>
          <a:stretch/>
        </p:blipFill>
        <p:spPr>
          <a:xfrm>
            <a:off x="138696" y="3792263"/>
            <a:ext cx="4279623" cy="2985055"/>
          </a:xfrm>
          <a:prstGeom prst="rect">
            <a:avLst/>
          </a:prstGeom>
        </p:spPr>
      </p:pic>
      <p:sp>
        <p:nvSpPr>
          <p:cNvPr id="49" name="Rechteck 48"/>
          <p:cNvSpPr/>
          <p:nvPr/>
        </p:nvSpPr>
        <p:spPr>
          <a:xfrm>
            <a:off x="514126" y="396611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14126" y="4706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14126" y="4793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14126" y="48848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14126" y="49854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14126" y="51860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14126" y="53984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14126" y="57165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14126" y="59464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14126" y="62255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14126" y="45844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1204611" y="451215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1" name="Rechteck 60"/>
          <p:cNvSpPr/>
          <p:nvPr/>
        </p:nvSpPr>
        <p:spPr>
          <a:xfrm>
            <a:off x="969503" y="1467683"/>
            <a:ext cx="2419156" cy="3688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2" name="Rechteck 61"/>
          <p:cNvSpPr/>
          <p:nvPr/>
        </p:nvSpPr>
        <p:spPr>
          <a:xfrm>
            <a:off x="514126" y="64480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088508" y="386207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088508" y="46020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088508" y="46894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088508" y="47808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088508" y="4881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088508" y="50819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088508" y="52944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088508" y="56125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088508" y="58424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5088508" y="61215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088508" y="44804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5778993" y="440811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5" name="Rechteck 74"/>
          <p:cNvSpPr/>
          <p:nvPr/>
        </p:nvSpPr>
        <p:spPr>
          <a:xfrm>
            <a:off x="5281696" y="1729988"/>
            <a:ext cx="2537413" cy="1136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6" name="Rechteck 75"/>
          <p:cNvSpPr/>
          <p:nvPr/>
        </p:nvSpPr>
        <p:spPr>
          <a:xfrm>
            <a:off x="5088508" y="63440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1691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5" t="26496" r="29955" b="63434"/>
          <a:stretch/>
        </p:blipFill>
        <p:spPr>
          <a:xfrm>
            <a:off x="926792" y="189466"/>
            <a:ext cx="972000" cy="1712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49" t="35615" r="30411" b="44773"/>
          <a:stretch/>
        </p:blipFill>
        <p:spPr>
          <a:xfrm>
            <a:off x="6513084" y="141311"/>
            <a:ext cx="972000" cy="3334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7569751" y="80384"/>
            <a:ext cx="5231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569751" y="137869"/>
            <a:ext cx="4260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569751" y="227066"/>
            <a:ext cx="8576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baseline="-25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983459" y="141311"/>
            <a:ext cx="10309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983459" y="215477"/>
            <a:ext cx="3817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/>
          <p:cNvCxnSpPr/>
          <p:nvPr/>
        </p:nvCxnSpPr>
        <p:spPr>
          <a:xfrm flipH="1">
            <a:off x="7495472" y="17941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7495472" y="24156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flipH="1">
            <a:off x="1909180" y="2275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>
            <a:off x="7495472" y="41290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flipH="1">
            <a:off x="1909180" y="24774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 flipH="1">
            <a:off x="1909180" y="31443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6236415" y="114292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43356" y="163679"/>
            <a:ext cx="441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6236415" y="279459"/>
            <a:ext cx="3345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7403298" y="226438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6232571" y="188196"/>
            <a:ext cx="3345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3" t="12093" r="22999" b="24190"/>
          <a:stretch/>
        </p:blipFill>
        <p:spPr>
          <a:xfrm>
            <a:off x="5400805" y="643547"/>
            <a:ext cx="3196558" cy="2650992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137" b="24559"/>
          <a:stretch/>
        </p:blipFill>
        <p:spPr>
          <a:xfrm>
            <a:off x="4687260" y="3493614"/>
            <a:ext cx="4287307" cy="3138736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4" t="4151" r="20932" b="33055"/>
          <a:stretch/>
        </p:blipFill>
        <p:spPr>
          <a:xfrm>
            <a:off x="618328" y="707749"/>
            <a:ext cx="3112034" cy="2612571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173" b="32870"/>
          <a:stretch/>
        </p:blipFill>
        <p:spPr>
          <a:xfrm>
            <a:off x="194684" y="3837475"/>
            <a:ext cx="4341095" cy="2792954"/>
          </a:xfrm>
          <a:prstGeom prst="rect">
            <a:avLst/>
          </a:prstGeom>
        </p:spPr>
      </p:pic>
      <p:sp>
        <p:nvSpPr>
          <p:cNvPr id="28" name="Rechteck 27"/>
          <p:cNvSpPr/>
          <p:nvPr/>
        </p:nvSpPr>
        <p:spPr>
          <a:xfrm>
            <a:off x="775581" y="383747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775581" y="45774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775581" y="46648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775581" y="47561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775581" y="48568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775581" y="50573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775581" y="52697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775581" y="55879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775581" y="58178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775581" y="60969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775581" y="44558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1466066" y="438351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0" name="Rechteck 39"/>
          <p:cNvSpPr/>
          <p:nvPr/>
        </p:nvSpPr>
        <p:spPr>
          <a:xfrm>
            <a:off x="789424" y="1681652"/>
            <a:ext cx="2460921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hteck 40"/>
          <p:cNvSpPr/>
          <p:nvPr/>
        </p:nvSpPr>
        <p:spPr>
          <a:xfrm>
            <a:off x="775581" y="63194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32321" y="387374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32321" y="46136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32321" y="47011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32321" y="47924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32321" y="48931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32321" y="50936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32321" y="53060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32321" y="56241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32321" y="58540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32321" y="61332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232321" y="44920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5922806" y="441978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4" name="Rechteck 53"/>
          <p:cNvSpPr/>
          <p:nvPr/>
        </p:nvSpPr>
        <p:spPr>
          <a:xfrm>
            <a:off x="5780814" y="1704257"/>
            <a:ext cx="2487206" cy="779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hteck 54"/>
          <p:cNvSpPr/>
          <p:nvPr/>
        </p:nvSpPr>
        <p:spPr>
          <a:xfrm>
            <a:off x="5232321" y="63557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0226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78" t="36583" r="59462" b="59356"/>
          <a:stretch/>
        </p:blipFill>
        <p:spPr>
          <a:xfrm>
            <a:off x="1141945" y="174218"/>
            <a:ext cx="234000" cy="711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2198612" y="139178"/>
            <a:ext cx="426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2124333" y="2423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865276" y="133351"/>
            <a:ext cx="334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866" b="27699"/>
          <a:stretch/>
        </p:blipFill>
        <p:spPr>
          <a:xfrm>
            <a:off x="668895" y="3584794"/>
            <a:ext cx="4525512" cy="300810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53" t="7105" r="18591" b="28622"/>
          <a:stretch/>
        </p:blipFill>
        <p:spPr>
          <a:xfrm>
            <a:off x="828747" y="364711"/>
            <a:ext cx="3165822" cy="2674044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421792" y="374752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421792" y="4487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421792" y="45748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421792" y="46662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421792" y="47669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421792" y="49674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421792" y="51798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421792" y="54979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421792" y="57278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421792" y="60070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421792" y="43658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112277" y="429356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0" name="Rechteck 19"/>
          <p:cNvSpPr/>
          <p:nvPr/>
        </p:nvSpPr>
        <p:spPr>
          <a:xfrm>
            <a:off x="1046362" y="1555437"/>
            <a:ext cx="750860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/>
          <p:cNvSpPr/>
          <p:nvPr/>
        </p:nvSpPr>
        <p:spPr>
          <a:xfrm>
            <a:off x="1421792" y="62294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3644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7</Words>
  <Application>Microsoft Office PowerPoint</Application>
  <PresentationFormat>Bildschirmpräsentation (4:3)</PresentationFormat>
  <Paragraphs>16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28T12:39:43Z</dcterms:created>
  <dcterms:modified xsi:type="dcterms:W3CDTF">2024-08-28T12:49:58Z</dcterms:modified>
</cp:coreProperties>
</file>